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9364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4477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3073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8152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7313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8316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9688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7122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1335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4387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6662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1452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/>
          <p:cNvGrpSpPr/>
          <p:nvPr/>
        </p:nvGrpSpPr>
        <p:grpSpPr>
          <a:xfrm>
            <a:off x="1111058" y="0"/>
            <a:ext cx="9772650" cy="6191250"/>
            <a:chOff x="1350352" y="0"/>
            <a:chExt cx="9772650" cy="6191250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50352" y="0"/>
              <a:ext cx="9772650" cy="6191250"/>
            </a:xfrm>
            <a:prstGeom prst="rect">
              <a:avLst/>
            </a:prstGeom>
          </p:spPr>
        </p:pic>
        <p:sp>
          <p:nvSpPr>
            <p:cNvPr id="6" name="ZoneTexte 5"/>
            <p:cNvSpPr txBox="1"/>
            <p:nvPr/>
          </p:nvSpPr>
          <p:spPr>
            <a:xfrm>
              <a:off x="2592836" y="246637"/>
              <a:ext cx="4892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2</a:t>
              </a: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10.68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1410756" y="4664404"/>
              <a:ext cx="4267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</a:t>
              </a:r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1</a:t>
              </a:r>
              <a:endParaRPr lang="fr-FR" sz="800" dirty="0" smtClean="0">
                <a:solidFill>
                  <a:schemeClr val="bg1">
                    <a:lumMod val="65000"/>
                  </a:schemeClr>
                </a:solidFill>
              </a:endParaRP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27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</p:grpSp>
      <p:sp>
        <p:nvSpPr>
          <p:cNvPr id="9" name="Google Shape;1414;p7"/>
          <p:cNvSpPr txBox="1">
            <a:spLocks/>
          </p:cNvSpPr>
          <p:nvPr/>
        </p:nvSpPr>
        <p:spPr>
          <a:xfrm>
            <a:off x="1104727" y="5900175"/>
            <a:ext cx="8124998" cy="1249847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t" anchorCtr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: </a:t>
            </a:r>
            <a:b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plane of a multivariate analysis based on SNPs obtained from targeted capture sequences of 304 accessions (Yang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19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With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officinaru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green,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robustu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blue,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spontaneu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red and interspecific hybrids (modern cultivars,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ber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sinens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orange and accessions from other genus in black.  </a:t>
            </a:r>
          </a:p>
          <a:p>
            <a:pPr marL="0" indent="0">
              <a:buNone/>
            </a:pP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431677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84</Words>
  <Application>Microsoft Office PowerPoint</Application>
  <PresentationFormat>Grand écran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ompidor</dc:creator>
  <cp:lastModifiedBy>pompidor</cp:lastModifiedBy>
  <cp:revision>9</cp:revision>
  <dcterms:created xsi:type="dcterms:W3CDTF">2020-09-15T06:59:05Z</dcterms:created>
  <dcterms:modified xsi:type="dcterms:W3CDTF">2020-12-09T14:11:14Z</dcterms:modified>
</cp:coreProperties>
</file>